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1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58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78F5FB-3811-4FB0-BDE0-CDD5FC8C5208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56BB34-E7D8-4E9F-9700-7EB4E1F5310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97697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1.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us-level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ive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undance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ata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eese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icrobiota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btained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y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ataxonomic</a:t>
            </a:r>
            <a:r>
              <a:rPr lang="es-E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s-E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</a:t>
            </a:r>
            <a:endParaRPr lang="es-E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56BB34-E7D8-4E9F-9700-7EB4E1F5310D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51502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919AE2E-4D32-DCD9-63D5-668ECF2D76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5F9B8A95-9ACA-A808-27A8-45A0642E2F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A09F9A-2AAF-C1EF-7E07-B53C181E3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A06B10D-BEDB-B804-D591-E6FAE4A2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422FA97-DB6E-B477-D4E5-BCF5C1E66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4326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BFA524-D9DD-1409-C000-3024F3571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56F7269-5118-1A94-9EB7-2B2F193613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7D5693F-F929-AEFE-8407-71002996B7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BC8E87D-751A-096B-D6AD-273978BB09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F4A19BF-D54E-3193-1824-2F6E9C661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9821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E7345B1-7C21-74F8-8891-179D1FCD57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24BDD91-1EE1-BF67-31FA-FE7811324F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34B3AB4-2D2D-4998-DD04-773DC38E3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278DC95-90C9-B536-8EB6-37D6573CF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59F2AFF-7A65-E5B5-BFB6-3D2D0869F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3815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4ED986-CD99-3521-8CCA-4066FFA5E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ADEA5B5-A349-3A89-D38A-A35147245C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388CD73-A1D2-63CB-6E5D-33F8922A7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A54BB8-EC36-9562-F081-68F98CAA6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AA5D66-BECE-B0AB-23C3-ED7F1EA715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0868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3B73D9-E498-6CA1-B54B-3712BE0D9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E655B4A-89A2-E843-7567-D6098F179F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62C3354-12D9-F5F8-A494-1482C40CA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55C2989-D72D-6EFC-0FEB-52358A84D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EEC0B87-A01E-5BC5-3C06-C64DE2B0F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8886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3111329-50F1-9127-B14E-AFB14346E1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850FDC0-E95F-918C-FA00-390710F8D1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662EF60-1DB6-BF85-7EFC-F9EF8E6E3E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6CE436B-6F71-C00D-0B52-24A9D58A2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09CB15F-0EAD-9C0A-2B43-4D2C0814F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F036939-98E7-8C22-ADAA-82CFE211E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9129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487E35-E9A6-8DED-2571-D47FBEB460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FCD7B6E-ACA2-20B3-C81F-0F355A001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C6A82C5-4625-132D-E508-C13362A45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B0C71DF-A3F8-6FA7-B257-DC85E1DB45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3FD97BA-4138-D7A5-B0B6-EF47DBB732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41FE9E4-35A0-CB2C-982E-83D0B2BEAA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040541C-2D5F-B57A-474C-4C3CB7F7B2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EEC7111-76BD-DD42-75E9-4583C8952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3407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E8C464-5819-8383-3211-2C5E931D8C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8C1652B-5A49-FC61-B450-A8DE85BAD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D0D4FD8-7277-0500-B161-BE16CDC2B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A06E2578-9490-A23D-F86D-37A95A57D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3918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3054FEC-EEBC-ECC8-4B32-C9C367AEA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7D58C34-6B91-A01F-2866-BF3112AFA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47C2E9E3-8684-AB6B-10B9-22E2CE365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31016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B79D1E-C1B0-6E3C-6159-861706E0B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DF2562A-5906-DB12-E2DD-4060074002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A6F5209-29A9-2D61-D730-E9F0575FDE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261A532-F076-FA65-92EF-05F6EE588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53A507D-3A02-12BA-2EC2-F67D90272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AB3504C-6BCA-6010-31AC-03456D0C0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6617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7A34208-E090-8A68-A43C-A144A7E739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0C1950B-C6C3-F106-14A3-1F326703F4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E68AC30-7A8B-18C7-8F28-F7B39513E6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7960782-6C6B-D86D-91DC-E4C99CE82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C7FAE9E-1F1A-DCA3-5F76-11BC24495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94902E3-41E2-5E67-25DF-57D4EE692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1335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DB13DCCC-8D07-DBCC-6502-1308932BF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07C988C-281F-94CB-E392-71A11C24E5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5E40A62-ACF8-49D0-AB47-DD60F0E1B4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F7B60E-8AE9-4569-B151-12A38F40322B}" type="datetimeFigureOut">
              <a:rPr lang="es-ES" smtClean="0"/>
              <a:t>07/04/2026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49D420C-2276-4491-81CE-2D9BA2A2AD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D05C444-0EC7-EB6C-B483-1E6993E1C9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ECE05E-899B-49C3-B49E-F0182DD3869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96510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BEE78668-4AA3-71F6-6404-63ECF1D50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3167" y="1016370"/>
            <a:ext cx="9805666" cy="482526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1C47E1FF-63FE-CD68-6E58-52E185EA718B}"/>
              </a:ext>
            </a:extLst>
          </p:cNvPr>
          <p:cNvSpPr txBox="1"/>
          <p:nvPr/>
        </p:nvSpPr>
        <p:spPr>
          <a:xfrm>
            <a:off x="-527902" y="566220"/>
            <a:ext cx="116721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656080">
              <a:spcBef>
                <a:spcPts val="1200"/>
              </a:spcBef>
              <a:spcAft>
                <a:spcPts val="600"/>
              </a:spcAft>
              <a:buNone/>
            </a:pPr>
            <a:r>
              <a:rPr lang="es-ES" sz="1200" b="1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able S1.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Genus-level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relative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abundanc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data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of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h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chees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microbiota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obtained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by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metataxonomic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analysis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.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Values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are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expressed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as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h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mean (%) and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h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SD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for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h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hre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cheeses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of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each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 </a:t>
            </a:r>
            <a:r>
              <a:rPr lang="es-ES" sz="1200" dirty="0" err="1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type</a:t>
            </a:r>
            <a:r>
              <a:rPr lang="es-ES" sz="1200" dirty="0">
                <a:effectLst/>
                <a:latin typeface="Palatino Linotype" panose="02040502050505030304" pitchFamily="18" charset="0"/>
                <a:ea typeface="Palatino Linotype" panose="02040502050505030304" pitchFamily="18" charset="0"/>
                <a:cs typeface="Palatino Linotype" panose="02040502050505030304" pitchFamily="18" charset="0"/>
              </a:rPr>
              <a:t>.</a:t>
            </a:r>
            <a:endParaRPr lang="es-ES" sz="1400" dirty="0">
              <a:effectLst/>
              <a:latin typeface="Palatino Linotype" panose="02040502050505030304" pitchFamily="18" charset="0"/>
              <a:ea typeface="Palatino Linotype" panose="02040502050505030304" pitchFamily="18" charset="0"/>
              <a:cs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51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09816F917F83E7418FE969C8DF633C73" ma:contentTypeVersion="5" ma:contentTypeDescription="Crear nuevo documento." ma:contentTypeScope="" ma:versionID="382b5d403964d85e646415afcecd03e3">
  <xsd:schema xmlns:xsd="http://www.w3.org/2001/XMLSchema" xmlns:xs="http://www.w3.org/2001/XMLSchema" xmlns:p="http://schemas.microsoft.com/office/2006/metadata/properties" xmlns:ns3="dada6164-e35d-42c5-96af-bbc193e231b4" targetNamespace="http://schemas.microsoft.com/office/2006/metadata/properties" ma:root="true" ma:fieldsID="fe251384a61f197922b0c2b47f13c4d1" ns3:_="">
    <xsd:import namespace="dada6164-e35d-42c5-96af-bbc193e231b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ada6164-e35d-42c5-96af-bbc193e231b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F37561F5-2492-4B2F-BC46-4D0E0B709AA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ada6164-e35d-42c5-96af-bbc193e231b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4C31DCC-5CAB-4859-8DFD-99F8FADD79E4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69DDF09-9857-4BA7-8202-ACAA163C4B58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dada6164-e35d-42c5-96af-bbc193e231b4"/>
    <ds:schemaRef ds:uri="http://purl.org/dc/terms/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0</Words>
  <Application>Microsoft Office PowerPoint</Application>
  <PresentationFormat>Panorámica</PresentationFormat>
  <Paragraphs>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sué Jara Pérez</dc:creator>
  <cp:lastModifiedBy>Josué Jara Pérez</cp:lastModifiedBy>
  <cp:revision>4</cp:revision>
  <dcterms:created xsi:type="dcterms:W3CDTF">2026-03-05T07:33:36Z</dcterms:created>
  <dcterms:modified xsi:type="dcterms:W3CDTF">2026-04-07T11:10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9816F917F83E7418FE969C8DF633C73</vt:lpwstr>
  </property>
</Properties>
</file>